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60" r:id="rId4"/>
    <p:sldId id="258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32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896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FB308-3DF2-C247-8025-5759F9FD51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53D34E-92C1-D24E-A4B3-096BCD18D4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DC3B42-9A33-884A-A217-66D855930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1AC698-514B-A847-9BEF-ADA3CCAA4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E9EFAF-0231-F843-847A-42A61A6D6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298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DAE59-CE39-1944-BC7E-9732023600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E74F74-28C8-FD47-9775-03D6288694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5C0F02-2C06-4846-A0D8-B47AF395C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F6D27D-C6C3-E74D-B0D7-7D2975727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435EB-5066-F046-9D76-BF5E07000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454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A63D32-9E5D-434A-8ED8-30B8C778D5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42D360-B5E9-A14F-9112-EBE67EE39C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85B8DF-4D33-CD4B-AC18-0862FCF11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4655D9-3A4B-0645-9184-EAFA81DD8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96E787-E82D-4043-8CAD-6AD5F085D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45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716B0-15F0-3D44-8E96-A07B0B0F7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33D10B-A8FF-1A42-952B-6350F7C90B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E3D63F-D088-714B-BB09-E739D84EC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E2166-0FC8-6F44-9627-D8D962840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33584-9895-4E41-ABDE-04A5517FD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96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A882F-0C32-DD4B-B39E-6E934FB9D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555A7A-DB32-5146-B892-013ED6611E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E71CB-760A-BD4A-8479-B21535DE8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EC4063-4F41-844A-A5E8-5632A58C5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8EDD91-6BF4-4147-AA09-1C880A41B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6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1D928-DF76-D74B-A74A-E3FFAA39E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1891F2-14B5-084E-AE1A-5B147C0EB7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2434C7-B235-B242-B311-008E838286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6EBE39-6D11-2F40-A366-96C8FF372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8D584E-AFC4-4649-9EFE-86D5C77B4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BB2AB0-4771-E14D-A9E2-9706A7817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064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280CC1-C5A0-504A-8E92-67DC3EDC0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3DEB3F-9A11-1249-897A-CB9210465F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2A87DC-1DE3-3147-961D-86EB7FA38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7591A4-0616-FD44-893A-0A38D57284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2B09427-72C0-FE48-BA89-DDF22FEEBA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F7FB80-7C51-754F-9A00-1E16B6239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060CAE-EBC5-1A4E-9859-67B62C14A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2CFFA3-31A6-0245-84F1-2DF7C4659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079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6BB42-4873-4C44-A98B-CFCCB16AD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4098FBA-F9A8-9D4C-B200-2774D8089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2752D3-7E29-684C-AF84-1E5F88464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80D071-BBAE-D84D-AE9E-4CBE9C493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644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62C3FE-BE14-A641-8B63-F36C3D5C7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45CDD7-D9CB-DD48-88F1-CBEE85885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B03611-C1D3-824E-9FDA-6BFC8AAE5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514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872B3-2CB2-374B-9065-69608A9FA5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F12571-E3B4-F047-B504-726F46417F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DDD6E6-4895-8B4E-A7E4-928BA9F976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BF6501-B2C7-9849-B9FF-1FDE11432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73EB9F-5FDE-BA4B-87A5-8FB11E6AA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6A6055-5EDB-DD41-9ED2-E1C18CEEB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100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AD7B3-91F2-D148-8C12-420EBCE27A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9817D6-F9E0-9341-A77C-E0474196C0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5F89C7-36F5-E94F-B402-6E005576CA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0DFA11-8CB2-7A46-AC87-18E4E5D4C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CD879C-B87A-334A-9EA2-C74088222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240853-9CE2-3B4B-8CD1-F45C46E41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63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2D6724-E6B2-AC46-A70F-A537D4708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3D736B-6935-7E4D-872F-D984BB73FE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7129DD-C289-9C4B-9551-3275A7D26B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C7EF8-3FCF-234D-BDC6-C0778A336412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82AF1D-1F3F-FF4E-AF41-D54BFDCE93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A23C2A-0F72-194C-BC2C-60CB85827E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6DA8E-3057-854B-B42A-B1902D408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524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6185263" y="1274365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938001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, TRP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498995" y="276012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H2AX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938827" y="1720698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-pS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487150" y="3252578"/>
            <a:ext cx="93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6420114" y="1720557"/>
            <a:ext cx="3114665" cy="351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4821" y="3242646"/>
            <a:ext cx="3119958" cy="3227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4821" y="2709464"/>
            <a:ext cx="3114666" cy="3969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6136165" y="4128072"/>
            <a:ext cx="35702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0  500   250   125      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498995" y="555696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H2A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938827" y="4559571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-pS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519678" y="6037174"/>
            <a:ext cx="93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448214" y="796188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B, 4h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5385123" y="3757521"/>
            <a:ext cx="123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RP, 4hrs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370" b="-20963"/>
          <a:stretch/>
        </p:blipFill>
        <p:spPr bwMode="auto">
          <a:xfrm>
            <a:off x="6480360" y="5582452"/>
            <a:ext cx="2537850" cy="3438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7370" b="5069"/>
          <a:stretch/>
        </p:blipFill>
        <p:spPr bwMode="auto">
          <a:xfrm>
            <a:off x="6480361" y="6082661"/>
            <a:ext cx="2537850" cy="264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370" b="-7235"/>
          <a:stretch/>
        </p:blipFill>
        <p:spPr bwMode="auto">
          <a:xfrm>
            <a:off x="6480360" y="4534959"/>
            <a:ext cx="2537850" cy="393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9654414" y="127315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840AED0-C164-9E4A-A108-E406A3889201}"/>
              </a:ext>
            </a:extLst>
          </p:cNvPr>
          <p:cNvSpPr txBox="1"/>
          <p:nvPr/>
        </p:nvSpPr>
        <p:spPr>
          <a:xfrm>
            <a:off x="9058679" y="409719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6" name="Picture 2">
            <a:extLst>
              <a:ext uri="{FF2B5EF4-FFF2-40B4-BE49-F238E27FC236}">
                <a16:creationId xmlns:a16="http://schemas.microsoft.com/office/drawing/2014/main" id="{AED5F0CF-0DB5-DD4B-A26E-AEBAD1A3366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301" b="-1"/>
          <a:stretch/>
        </p:blipFill>
        <p:spPr bwMode="auto">
          <a:xfrm>
            <a:off x="6414821" y="2184650"/>
            <a:ext cx="3114666" cy="3638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F0555F5-6E31-E548-B166-9154312779A9}"/>
              </a:ext>
            </a:extLst>
          </p:cNvPr>
          <p:cNvSpPr txBox="1"/>
          <p:nvPr/>
        </p:nvSpPr>
        <p:spPr>
          <a:xfrm>
            <a:off x="4938827" y="2185857"/>
            <a:ext cx="1501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 Tota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38B5069-AF62-9F41-A800-FC053E3B66DE}"/>
              </a:ext>
            </a:extLst>
          </p:cNvPr>
          <p:cNvSpPr txBox="1"/>
          <p:nvPr/>
        </p:nvSpPr>
        <p:spPr>
          <a:xfrm>
            <a:off x="4894456" y="5016822"/>
            <a:ext cx="1501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 Total</a:t>
            </a:r>
          </a:p>
        </p:txBody>
      </p:sp>
      <p:pic>
        <p:nvPicPr>
          <p:cNvPr id="29" name="Picture 3">
            <a:extLst>
              <a:ext uri="{FF2B5EF4-FFF2-40B4-BE49-F238E27FC236}">
                <a16:creationId xmlns:a16="http://schemas.microsoft.com/office/drawing/2014/main" id="{1C00A8FE-3F70-6145-B399-F9C1628889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0360" y="5027065"/>
            <a:ext cx="2537850" cy="482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46055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1992623" y="4035936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B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C2875D8-EB14-B04A-AE84-E540173B7E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8016" y="3290904"/>
            <a:ext cx="4706013" cy="2258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2350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2179123" y="4259282"/>
            <a:ext cx="1505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RNAPI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B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1BB9664-1362-1047-ABE7-F41F5DA268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6773" y="3290905"/>
            <a:ext cx="4768173" cy="2306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87162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1688399" y="3676708"/>
            <a:ext cx="93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B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3FCB09A-4710-ED48-9D04-8030450105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1471" y="3221389"/>
            <a:ext cx="5615215" cy="1916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24945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2752037" y="3965368"/>
            <a:ext cx="93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23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RP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EAA1004-BCC0-8A40-9172-784483337E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2540" y="3430887"/>
            <a:ext cx="6752803" cy="2024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51410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2224631" y="4204854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23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RP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5F3C951-FE55-1944-8114-90E3545FD9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4728" y="3290904"/>
            <a:ext cx="6819986" cy="2783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83152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4421777" y="292204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100   50      25    12.5   6.25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D6E802-502B-2A42-B07D-5EE3F26153AD}"/>
              </a:ext>
            </a:extLst>
          </p:cNvPr>
          <p:cNvSpPr txBox="1"/>
          <p:nvPr/>
        </p:nvSpPr>
        <p:spPr>
          <a:xfrm>
            <a:off x="136736" y="150897"/>
            <a:ext cx="34034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RB Dosage Titration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oh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mage IDs: 0000082-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2432500" y="4449257"/>
            <a:ext cx="1505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RNAPI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B3292E-D812-D649-B1CC-B6DBF525D426}"/>
              </a:ext>
            </a:extLst>
          </p:cNvPr>
          <p:cNvSpPr txBox="1"/>
          <p:nvPr/>
        </p:nvSpPr>
        <p:spPr>
          <a:xfrm>
            <a:off x="3684728" y="2443869"/>
            <a:ext cx="123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RP, 4h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D6022-3D18-4C49-8F7C-93FDF554A91D}"/>
              </a:ext>
            </a:extLst>
          </p:cNvPr>
          <p:cNvSpPr txBox="1"/>
          <p:nvPr/>
        </p:nvSpPr>
        <p:spPr>
          <a:xfrm>
            <a:off x="8043328" y="292157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390A16-C4FC-854B-A057-8E9B9DCCB8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92"/>
          <a:stretch/>
        </p:blipFill>
        <p:spPr>
          <a:xfrm>
            <a:off x="11005481" y="2072305"/>
            <a:ext cx="1114319" cy="336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5EEE60F-8777-D342-BCE0-15EF3D01C5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38105" y="3290904"/>
            <a:ext cx="6403324" cy="2686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9397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206</Words>
  <Application>Microsoft Macintosh PowerPoint</Application>
  <PresentationFormat>Widescreen</PresentationFormat>
  <Paragraphs>6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20</cp:revision>
  <dcterms:created xsi:type="dcterms:W3CDTF">2018-05-29T01:08:26Z</dcterms:created>
  <dcterms:modified xsi:type="dcterms:W3CDTF">2019-11-24T22:14:07Z</dcterms:modified>
</cp:coreProperties>
</file>